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21945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5920B-C9C3-4614-AAED-D42B6522CC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822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12684960"/>
            <a:ext cx="822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3591B-5290-4261-9FCD-FBB2A385EE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512100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1268496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1268496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40735-B49D-456A-818E-CBE505D457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264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5121000"/>
            <a:ext cx="264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5121000"/>
            <a:ext cx="264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12684960"/>
            <a:ext cx="264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12684960"/>
            <a:ext cx="264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12684960"/>
            <a:ext cx="264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E155A-0377-40A5-9B0C-B5625560CE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5121000"/>
            <a:ext cx="8229600" cy="1448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ADF7F-D72C-430C-BCE4-F70CD419E4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8229600" cy="144810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9FC54-B9B4-4507-B14D-B8062FBC5E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4015800" cy="144810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5121000"/>
            <a:ext cx="4015800" cy="144810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B6B7D-C11A-4486-AB24-7AA1D9CF14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FACC5-E0FE-4A94-8EF7-2A3E865D28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879480"/>
            <a:ext cx="8229600" cy="169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9DCCA-6CEB-496D-972A-E3A8B851C6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5121000"/>
            <a:ext cx="4015800" cy="144810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1268496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64BB4-0986-4134-8C39-C245EA6783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4015800" cy="144810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512100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1268496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DEA75-CF3B-44D4-9359-2E12708CDC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512100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5121000"/>
            <a:ext cx="40158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12684960"/>
            <a:ext cx="8229600" cy="69073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4B0B8-4A90-466A-9F6C-102743624D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879480"/>
            <a:ext cx="8229600" cy="36576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5121000"/>
            <a:ext cx="8229600" cy="144810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t">
            <a:normAutofit/>
          </a:bodyPr>
          <a:p>
            <a:pPr marL="446040" indent="-446040"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1" marL="966960" indent="-371520">
              <a:spcBef>
                <a:spcPts val="104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2" marL="1487520" indent="-297000"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3" marL="2082960" indent="-297000">
              <a:spcBef>
                <a:spcPts val="104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4" marL="2678040" indent="-29664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5" marL="2678040" indent="-29664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6" marL="2678040" indent="-29664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20340360"/>
            <a:ext cx="2133720" cy="11667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20340360"/>
            <a:ext cx="2895840" cy="11667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20340360"/>
            <a:ext cx="2133720" cy="11667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400" bIns="594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9C7AA4-E5FD-4FD9-9322-81A16ABD93B8}" type="slidenum">
              <a:rPr b="0" lang="en-US" sz="1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"/>
          <p:cNvGrpSpPr/>
          <p:nvPr/>
        </p:nvGrpSpPr>
        <p:grpSpPr>
          <a:xfrm>
            <a:off x="176040" y="152280"/>
            <a:ext cx="9067320" cy="21641040"/>
            <a:chOff x="176040" y="152280"/>
            <a:chExt cx="9067320" cy="21641040"/>
          </a:xfrm>
        </p:grpSpPr>
        <p:sp>
          <p:nvSpPr>
            <p:cNvPr id="42" name="TextBox 6"/>
            <p:cNvSpPr/>
            <p:nvPr/>
          </p:nvSpPr>
          <p:spPr>
            <a:xfrm>
              <a:off x="5892840" y="549000"/>
              <a:ext cx="3251160" cy="13286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19160" rIns="119160" tIns="59400" bIns="594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dditional file 7</a:t>
              </a: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 K means clusters comparing the expressional level of  transcripts having beyond +/-2 fold change and p &lt;= 0.05 at 0,1,6 and 120 hours after inoculation. Green and orange represent down-regulation and up-regulation respectively. The intensity of color signifies the degree of fold change.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2"/>
            <p:cNvGrpSpPr/>
            <p:nvPr/>
          </p:nvGrpSpPr>
          <p:grpSpPr>
            <a:xfrm>
              <a:off x="5575680" y="20969640"/>
              <a:ext cx="3667680" cy="747720"/>
              <a:chOff x="5575680" y="20969640"/>
              <a:chExt cx="3667680" cy="747720"/>
            </a:xfrm>
          </p:grpSpPr>
          <p:pic>
            <p:nvPicPr>
              <p:cNvPr id="44" name="Picture 3" descr="code.jpg"/>
              <p:cNvPicPr/>
              <p:nvPr/>
            </p:nvPicPr>
            <p:blipFill>
              <a:blip r:embed="rId1"/>
              <a:stretch/>
            </p:blipFill>
            <p:spPr>
              <a:xfrm flipH="1" rot="10800000">
                <a:off x="5827320" y="21274560"/>
                <a:ext cx="3124080" cy="442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Box 4"/>
              <p:cNvSpPr/>
              <p:nvPr/>
            </p:nvSpPr>
            <p:spPr>
              <a:xfrm>
                <a:off x="5575680" y="20969640"/>
                <a:ext cx="3667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-25 -10 -5  -2  -1    0      1   2   5   10  2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46" name="Picture 7" descr="274 annotated k clus.tif"/>
            <p:cNvPicPr/>
            <p:nvPr/>
          </p:nvPicPr>
          <p:blipFill>
            <a:blip r:embed="rId2"/>
            <a:stretch/>
          </p:blipFill>
          <p:spPr>
            <a:xfrm>
              <a:off x="176040" y="383760"/>
              <a:ext cx="5386320" cy="21409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7"/>
            <p:cNvSpPr/>
            <p:nvPr/>
          </p:nvSpPr>
          <p:spPr>
            <a:xfrm>
              <a:off x="3928680" y="152280"/>
              <a:ext cx="1956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h    1h    6h  120 ha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mpa</dc:creator>
  <dc:description/>
  <dc:language>en-US</dc:language>
  <cp:lastModifiedBy>Prof. Sampa Das</cp:lastModifiedBy>
  <dcterms:modified xsi:type="dcterms:W3CDTF">2011-12-19T09:41:01Z</dcterms:modified>
  <cp:revision>11</cp:revision>
  <dc:subject/>
  <dc:title>Slide 1</dc:title>
</cp:coreProperties>
</file>